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0" r:id="rId2"/>
    <p:sldId id="314" r:id="rId3"/>
    <p:sldId id="311" r:id="rId4"/>
    <p:sldId id="315" r:id="rId5"/>
    <p:sldId id="312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74C19D-8A6B-1C20-84AB-0896B262F5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E225DBB-3359-60C7-3B91-6DCCA7B055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500268-300A-3D22-3F68-CE4822E0E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E4B02C-1B16-2F19-DA24-92810688F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48C4D6-FF58-D81E-54B1-4471F0418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658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BB904D-60B5-8855-A26C-59378F1A1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8FDCF91-3FCD-BBE0-7596-9868185FD7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1FC9A2-11F9-BEFD-350D-7C5A74A81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AABB86-FEAF-345D-1750-0C078E7D9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7519AA-653A-7831-3EDF-292043260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041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7A0C0D4-A22E-F64C-CA96-AD17A6C4C4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84A2EAE-B883-5FB2-F96D-B070505692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AB044D-3778-5AC4-37B5-0D5FEE10B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97D192-AABE-3E86-E322-E03572F5C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EA0539-17D4-F9BD-C877-3729F1BA3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683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DC0DFC-39D8-B6C6-A14A-9A73F34051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20B67EF-E855-588A-0E57-9C240A9433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F28751-4E2C-A285-E2CB-B229EA3E6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5117B2-16C3-BD2C-1309-8520BC687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25BF2E-0BF1-00C5-5978-79DA6840C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061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14DB3A-7CF2-B44B-51E1-A5A7B7942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E71794-674D-0C50-0B04-DED97B06E5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5F6101-7AC5-65D3-7759-1368FBE4F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0D0996-635A-B71E-107F-4844C602D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AB2193-5997-DDDA-5756-79276591C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039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3C44A2-3813-3337-CB03-24F785188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718B75A-D49C-A452-C630-8EEC75C98B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E65A7FB-4579-6429-ACE4-C3E284DCD8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168A63C-9815-33A2-27A6-940C4F3DA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19E77F-C1A9-499B-FE7D-DB32CE76F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DF6209-BEAB-42AB-5A2A-CAC48284C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712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F079A9-5829-EE26-E26C-7CD19689AF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3EBCF79-FBF4-BAAA-468B-A014B195DE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9108AEE-703A-6487-46CB-53EC878065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13F83E8-2F2F-FC08-94B9-00F6BC87E4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B5ADB4E-E507-D026-9DD7-E7D283A931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28B5B78-1F88-3402-CA98-49338D140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BA77A77-7418-F4DD-B45C-7EA51AFEE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4F58773-8021-396C-2BB7-51FD928CA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04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BF8DD4-5A29-B315-C60E-26643568E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F74B078-E4D8-8052-857D-72DEE96F6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D83B8DC-A811-F9C7-E420-D342F07BC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6F907A5-02D8-E838-0FD0-0D1369E93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4025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2C527E4-9A72-6727-EE8D-F7C77B9BA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D6EF42D-4092-C7CB-8017-2E96C2E6C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F49DDF5-37D3-659A-3378-517B5773F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1224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43B799-BA5D-9458-E7B4-C7715D512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079C4E-81F6-2946-A718-63A1B74A8A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2B8008-E97D-BBCE-9E35-85BAB45D95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7F8DF6F-E797-ECF4-4BCD-38F4892AD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96A750-BE13-6900-68C3-D0547E1F0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4AAAD8-5FFB-C3D1-4A1C-323A7B5D9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8116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0E52FF-0A3E-EAF1-AA55-3321B6DDEC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E3B49CB-9A15-B2C7-9D39-740A8826E0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DE97A93-8C66-62F7-1BEB-FDD54ADDA8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59C10AB-48C9-2BFF-52E0-9ABA3A0CC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D08E2C3-AF76-93A2-51C8-502E9D745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75CDB83-0593-C455-B7F3-D3DD2612F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968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177A19B-99A4-3AA2-082C-A37ACF750E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2D9A5EB-F577-F814-D7A1-C67E68401A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56277F-9435-1D58-5778-48AB3EF390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9BDEE-AFEE-45F7-B628-477973E415BB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7A21F5-535A-52B3-06AD-9CF5E9F10A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067C8A-CDDA-799A-4346-8B498B3B78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00E81-6718-4036-9B0F-BC8B862DB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7592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40DA13-C6F7-AAEC-643D-1370FA688656}"/>
              </a:ext>
            </a:extLst>
          </p:cNvPr>
          <p:cNvSpPr txBox="1"/>
          <p:nvPr/>
        </p:nvSpPr>
        <p:spPr>
          <a:xfrm>
            <a:off x="454606" y="693335"/>
            <a:ext cx="285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1a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C9186ED-59F8-CF07-BA48-42B850B9795D}"/>
              </a:ext>
            </a:extLst>
          </p:cNvPr>
          <p:cNvSpPr txBox="1"/>
          <p:nvPr/>
        </p:nvSpPr>
        <p:spPr>
          <a:xfrm>
            <a:off x="6125564" y="693335"/>
            <a:ext cx="3115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1b</a:t>
            </a: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C3C9FD28-CACE-0F6A-B3A9-49178DFCC2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5564" y="1408996"/>
            <a:ext cx="5568594" cy="419171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141FC408-5787-8A6B-D4FD-525FA0EC3F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4606" y="1408996"/>
            <a:ext cx="5609336" cy="4191714"/>
          </a:xfrm>
          <a:prstGeom prst="rect">
            <a:avLst/>
          </a:prstGeom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C3F3B3CC-C174-AFAD-2605-69D66E77B349}"/>
              </a:ext>
            </a:extLst>
          </p:cNvPr>
          <p:cNvSpPr/>
          <p:nvPr/>
        </p:nvSpPr>
        <p:spPr>
          <a:xfrm>
            <a:off x="9597006" y="4219662"/>
            <a:ext cx="1895911" cy="260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0AE5ADE-FF4B-5C08-5AE5-A74E19C46CDC}"/>
              </a:ext>
            </a:extLst>
          </p:cNvPr>
          <p:cNvGrpSpPr/>
          <p:nvPr/>
        </p:nvGrpSpPr>
        <p:grpSpPr>
          <a:xfrm>
            <a:off x="9174163" y="4218603"/>
            <a:ext cx="2230108" cy="233628"/>
            <a:chOff x="3061982" y="698424"/>
            <a:chExt cx="2230108" cy="233628"/>
          </a:xfrm>
        </p:grpSpPr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8E2F3665-2D62-1702-F911-61D7A6573295}"/>
                </a:ext>
              </a:extLst>
            </p:cNvPr>
            <p:cNvCxnSpPr/>
            <p:nvPr/>
          </p:nvCxnSpPr>
          <p:spPr>
            <a:xfrm>
              <a:off x="3061982" y="805343"/>
              <a:ext cx="293614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E6E520B2-3139-0AD7-6C89-0310CE8E6629}"/>
                </a:ext>
              </a:extLst>
            </p:cNvPr>
            <p:cNvSpPr txBox="1"/>
            <p:nvPr/>
          </p:nvSpPr>
          <p:spPr>
            <a:xfrm>
              <a:off x="3335670" y="698424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ISS 1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9D915ED4-14E2-2538-374B-7F3B48047CAC}"/>
                </a:ext>
              </a:extLst>
            </p:cNvPr>
            <p:cNvCxnSpPr/>
            <p:nvPr/>
          </p:nvCxnSpPr>
          <p:spPr>
            <a:xfrm>
              <a:off x="3818390" y="806741"/>
              <a:ext cx="293614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D8E4B07-BA38-6876-F416-528C9916AA12}"/>
                </a:ext>
              </a:extLst>
            </p:cNvPr>
            <p:cNvSpPr txBox="1"/>
            <p:nvPr/>
          </p:nvSpPr>
          <p:spPr>
            <a:xfrm>
              <a:off x="4092078" y="699822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ISS 2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B2B5A377-C596-6408-3F82-F6349C85C124}"/>
                </a:ext>
              </a:extLst>
            </p:cNvPr>
            <p:cNvCxnSpPr/>
            <p:nvPr/>
          </p:nvCxnSpPr>
          <p:spPr>
            <a:xfrm>
              <a:off x="4558020" y="808139"/>
              <a:ext cx="293614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E7638DF2-6C82-8BB2-88A5-84E5223A5D00}"/>
                </a:ext>
              </a:extLst>
            </p:cNvPr>
            <p:cNvSpPr txBox="1"/>
            <p:nvPr/>
          </p:nvSpPr>
          <p:spPr>
            <a:xfrm>
              <a:off x="4831708" y="701220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ISS 3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01271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6FEE1877-F4DF-9FBC-B541-FBE6FEFB13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9036" y="1694508"/>
            <a:ext cx="5485651" cy="412787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A0F0AD7-BF73-8769-B503-8404D00DFE2E}"/>
              </a:ext>
            </a:extLst>
          </p:cNvPr>
          <p:cNvSpPr txBox="1"/>
          <p:nvPr/>
        </p:nvSpPr>
        <p:spPr>
          <a:xfrm>
            <a:off x="343949" y="913464"/>
            <a:ext cx="2905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1c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852F0B0-33A0-E15B-1896-3793B76ED882}"/>
              </a:ext>
            </a:extLst>
          </p:cNvPr>
          <p:cNvSpPr txBox="1"/>
          <p:nvPr/>
        </p:nvSpPr>
        <p:spPr>
          <a:xfrm>
            <a:off x="5939036" y="913464"/>
            <a:ext cx="2905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1d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FD687A2C-850B-ABE4-C7A6-3FFED487AC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949" y="1694508"/>
            <a:ext cx="5485651" cy="4144230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27E28D3-612C-A02B-17DC-5BDDDE2D26FD}"/>
              </a:ext>
            </a:extLst>
          </p:cNvPr>
          <p:cNvSpPr/>
          <p:nvPr/>
        </p:nvSpPr>
        <p:spPr>
          <a:xfrm>
            <a:off x="3892492" y="4597167"/>
            <a:ext cx="1736521" cy="2181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EBE1D4A8-8315-ED37-9688-577F4B803AEF}"/>
              </a:ext>
            </a:extLst>
          </p:cNvPr>
          <p:cNvSpPr/>
          <p:nvPr/>
        </p:nvSpPr>
        <p:spPr>
          <a:xfrm>
            <a:off x="9336947" y="4588778"/>
            <a:ext cx="1879134" cy="1006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D519561F-5005-69B5-8CCC-4B8C63FD08D4}"/>
              </a:ext>
            </a:extLst>
          </p:cNvPr>
          <p:cNvGrpSpPr/>
          <p:nvPr/>
        </p:nvGrpSpPr>
        <p:grpSpPr>
          <a:xfrm>
            <a:off x="3443843" y="4497897"/>
            <a:ext cx="2168386" cy="237823"/>
            <a:chOff x="8049625" y="966367"/>
            <a:chExt cx="2168386" cy="237823"/>
          </a:xfrm>
        </p:grpSpPr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36BA2C7D-272C-9BFC-FA17-18BF563976AF}"/>
                </a:ext>
              </a:extLst>
            </p:cNvPr>
            <p:cNvCxnSpPr/>
            <p:nvPr/>
          </p:nvCxnSpPr>
          <p:spPr>
            <a:xfrm>
              <a:off x="8049625" y="1080277"/>
              <a:ext cx="293614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BB9BAC9-2BA3-F672-A9A9-CFC7FFC9A36B}"/>
                </a:ext>
              </a:extLst>
            </p:cNvPr>
            <p:cNvSpPr txBox="1"/>
            <p:nvPr/>
          </p:nvSpPr>
          <p:spPr>
            <a:xfrm>
              <a:off x="8323313" y="973358"/>
              <a:ext cx="88197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without EMD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99B0C522-0AF9-C927-ECE2-29A57801659A}"/>
                </a:ext>
              </a:extLst>
            </p:cNvPr>
            <p:cNvCxnSpPr/>
            <p:nvPr/>
          </p:nvCxnSpPr>
          <p:spPr>
            <a:xfrm>
              <a:off x="9267428" y="1081675"/>
              <a:ext cx="293614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D675F5D-3DD7-27C3-90B6-CD984D968CF8}"/>
                </a:ext>
              </a:extLst>
            </p:cNvPr>
            <p:cNvSpPr txBox="1"/>
            <p:nvPr/>
          </p:nvSpPr>
          <p:spPr>
            <a:xfrm>
              <a:off x="9507560" y="966367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with EMD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2571E037-49F3-8AD3-FAEB-E17DCD020F38}"/>
              </a:ext>
            </a:extLst>
          </p:cNvPr>
          <p:cNvGrpSpPr/>
          <p:nvPr/>
        </p:nvGrpSpPr>
        <p:grpSpPr>
          <a:xfrm>
            <a:off x="8744512" y="4514541"/>
            <a:ext cx="2348731" cy="233628"/>
            <a:chOff x="8543177" y="444762"/>
            <a:chExt cx="2348731" cy="233628"/>
          </a:xfrm>
        </p:grpSpPr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2DD26908-804C-6DC6-2F13-3E2CED9F70FD}"/>
                </a:ext>
              </a:extLst>
            </p:cNvPr>
            <p:cNvCxnSpPr/>
            <p:nvPr/>
          </p:nvCxnSpPr>
          <p:spPr>
            <a:xfrm>
              <a:off x="8543177" y="551681"/>
              <a:ext cx="293614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2D24A73-19CB-3001-E034-025C1E37ADFC}"/>
                </a:ext>
              </a:extLst>
            </p:cNvPr>
            <p:cNvSpPr txBox="1"/>
            <p:nvPr/>
          </p:nvSpPr>
          <p:spPr>
            <a:xfrm>
              <a:off x="8816865" y="444762"/>
              <a:ext cx="4651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FCI 0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9A13850C-4BEF-6AEC-0566-85D1563E6EA3}"/>
                </a:ext>
              </a:extLst>
            </p:cNvPr>
            <p:cNvCxnSpPr/>
            <p:nvPr/>
          </p:nvCxnSpPr>
          <p:spPr>
            <a:xfrm>
              <a:off x="9299585" y="553079"/>
              <a:ext cx="293614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F49BCE8C-356A-90F5-E0AE-F9EFB9FD8A29}"/>
                </a:ext>
              </a:extLst>
            </p:cNvPr>
            <p:cNvSpPr txBox="1"/>
            <p:nvPr/>
          </p:nvSpPr>
          <p:spPr>
            <a:xfrm>
              <a:off x="9573273" y="446160"/>
              <a:ext cx="4651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FCI 1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77350258-F9ED-CE68-7F9D-DE1DC13E7D50}"/>
                </a:ext>
              </a:extLst>
            </p:cNvPr>
            <p:cNvCxnSpPr/>
            <p:nvPr/>
          </p:nvCxnSpPr>
          <p:spPr>
            <a:xfrm>
              <a:off x="10039215" y="554477"/>
              <a:ext cx="293614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C1653C9-D098-737D-9AD1-56307716116D}"/>
                </a:ext>
              </a:extLst>
            </p:cNvPr>
            <p:cNvSpPr txBox="1"/>
            <p:nvPr/>
          </p:nvSpPr>
          <p:spPr>
            <a:xfrm>
              <a:off x="10312903" y="447558"/>
              <a:ext cx="5790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FCI 2-3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962520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141A360-6907-84CC-A884-FF26472A8569}"/>
              </a:ext>
            </a:extLst>
          </p:cNvPr>
          <p:cNvSpPr txBox="1"/>
          <p:nvPr/>
        </p:nvSpPr>
        <p:spPr>
          <a:xfrm>
            <a:off x="531308" y="834639"/>
            <a:ext cx="285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2a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149D500-8D45-92B6-6EE5-6743DA0318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8490" y="1675631"/>
            <a:ext cx="5212069" cy="393118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DA21905-7406-ADB2-B391-B1A4C86E8291}"/>
              </a:ext>
            </a:extLst>
          </p:cNvPr>
          <p:cNvSpPr txBox="1"/>
          <p:nvPr/>
        </p:nvSpPr>
        <p:spPr>
          <a:xfrm>
            <a:off x="6262504" y="834639"/>
            <a:ext cx="28600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2b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96546BE0-FBCF-1D12-5FFA-25DBB4953A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2504" y="1675630"/>
            <a:ext cx="5224265" cy="3931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80109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5EEF29A-1527-7AFA-2F6F-70C6B891A97F}"/>
              </a:ext>
            </a:extLst>
          </p:cNvPr>
          <p:cNvSpPr txBox="1"/>
          <p:nvPr/>
        </p:nvSpPr>
        <p:spPr>
          <a:xfrm>
            <a:off x="533073" y="885814"/>
            <a:ext cx="2844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2c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5632B025-FC68-C34A-05FA-BD3393B0C3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073" y="1673472"/>
            <a:ext cx="5346431" cy="403644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25B15E3-371F-0EEA-1B21-45AE3194F01C}"/>
              </a:ext>
            </a:extLst>
          </p:cNvPr>
          <p:cNvSpPr txBox="1"/>
          <p:nvPr/>
        </p:nvSpPr>
        <p:spPr>
          <a:xfrm>
            <a:off x="6414905" y="877548"/>
            <a:ext cx="28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2d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18F04224-90F0-1184-29B2-30A4AF3879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4905" y="1673472"/>
            <a:ext cx="5346430" cy="4036448"/>
          </a:xfrm>
          <a:prstGeom prst="rect">
            <a:avLst/>
          </a:prstGeom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3A84EB0E-F013-C878-F3F6-AC29872619D2}"/>
              </a:ext>
            </a:extLst>
          </p:cNvPr>
          <p:cNvSpPr/>
          <p:nvPr/>
        </p:nvSpPr>
        <p:spPr>
          <a:xfrm>
            <a:off x="3923084" y="4404220"/>
            <a:ext cx="1764652" cy="2265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1DADF167-61BA-96FA-5517-9F7BB9742D7F}"/>
              </a:ext>
            </a:extLst>
          </p:cNvPr>
          <p:cNvGrpSpPr/>
          <p:nvPr/>
        </p:nvGrpSpPr>
        <p:grpSpPr>
          <a:xfrm>
            <a:off x="2978276" y="4287406"/>
            <a:ext cx="2532915" cy="233628"/>
            <a:chOff x="3649396" y="510670"/>
            <a:chExt cx="2532915" cy="233628"/>
          </a:xfrm>
        </p:grpSpPr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14926953-F4A9-6459-91DE-A0D2694AFC79}"/>
                </a:ext>
              </a:extLst>
            </p:cNvPr>
            <p:cNvCxnSpPr/>
            <p:nvPr/>
          </p:nvCxnSpPr>
          <p:spPr>
            <a:xfrm>
              <a:off x="3649396" y="617589"/>
              <a:ext cx="293614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16E0709A-1A9F-58ED-BD7C-21857E5A36A0}"/>
                </a:ext>
              </a:extLst>
            </p:cNvPr>
            <p:cNvSpPr txBox="1"/>
            <p:nvPr/>
          </p:nvSpPr>
          <p:spPr>
            <a:xfrm>
              <a:off x="3923084" y="510670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R-ISS 1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0AF4D7EA-4BEE-4ADF-13B7-71FCDB11104E}"/>
                </a:ext>
              </a:extLst>
            </p:cNvPr>
            <p:cNvCxnSpPr/>
            <p:nvPr/>
          </p:nvCxnSpPr>
          <p:spPr>
            <a:xfrm>
              <a:off x="4489694" y="618987"/>
              <a:ext cx="293614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0DBBC4DD-FF86-1180-1899-A9D847B4E594}"/>
                </a:ext>
              </a:extLst>
            </p:cNvPr>
            <p:cNvSpPr txBox="1"/>
            <p:nvPr/>
          </p:nvSpPr>
          <p:spPr>
            <a:xfrm>
              <a:off x="4763382" y="512068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R-ISS 2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D66E9F88-73DC-6570-4E65-7467B8CC6424}"/>
                </a:ext>
              </a:extLst>
            </p:cNvPr>
            <p:cNvCxnSpPr/>
            <p:nvPr/>
          </p:nvCxnSpPr>
          <p:spPr>
            <a:xfrm>
              <a:off x="5321603" y="620385"/>
              <a:ext cx="293614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6FE96B7-5DAD-CA41-3343-47205F0C3990}"/>
                </a:ext>
              </a:extLst>
            </p:cNvPr>
            <p:cNvSpPr txBox="1"/>
            <p:nvPr/>
          </p:nvSpPr>
          <p:spPr>
            <a:xfrm>
              <a:off x="5595291" y="513466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R-ISS 3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30662378-B63F-E31A-68BF-87F0480B15E9}"/>
              </a:ext>
            </a:extLst>
          </p:cNvPr>
          <p:cNvSpPr/>
          <p:nvPr/>
        </p:nvSpPr>
        <p:spPr>
          <a:xfrm>
            <a:off x="9756396" y="4394325"/>
            <a:ext cx="1820411" cy="2363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C29E3C06-7DEC-A909-F98D-080EEC9348CE}"/>
              </a:ext>
            </a:extLst>
          </p:cNvPr>
          <p:cNvGrpSpPr/>
          <p:nvPr/>
        </p:nvGrpSpPr>
        <p:grpSpPr>
          <a:xfrm>
            <a:off x="8978517" y="4303848"/>
            <a:ext cx="2532915" cy="233628"/>
            <a:chOff x="3649396" y="510670"/>
            <a:chExt cx="2532915" cy="233628"/>
          </a:xfrm>
        </p:grpSpPr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938B2C36-026D-0A66-8DED-AE6B92D0FA32}"/>
                </a:ext>
              </a:extLst>
            </p:cNvPr>
            <p:cNvCxnSpPr/>
            <p:nvPr/>
          </p:nvCxnSpPr>
          <p:spPr>
            <a:xfrm>
              <a:off x="3649396" y="617589"/>
              <a:ext cx="293614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2B204FD6-7BEA-FEEF-DB3C-BB120027DCF5}"/>
                </a:ext>
              </a:extLst>
            </p:cNvPr>
            <p:cNvSpPr txBox="1"/>
            <p:nvPr/>
          </p:nvSpPr>
          <p:spPr>
            <a:xfrm>
              <a:off x="3923084" y="510670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R-ISS 1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F1E3CFA0-9270-BC4C-333A-B68D1B27A5B5}"/>
                </a:ext>
              </a:extLst>
            </p:cNvPr>
            <p:cNvCxnSpPr/>
            <p:nvPr/>
          </p:nvCxnSpPr>
          <p:spPr>
            <a:xfrm>
              <a:off x="4489694" y="618987"/>
              <a:ext cx="293614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8EF113D4-1C08-6A99-0886-E436A6AF8429}"/>
                </a:ext>
              </a:extLst>
            </p:cNvPr>
            <p:cNvSpPr txBox="1"/>
            <p:nvPr/>
          </p:nvSpPr>
          <p:spPr>
            <a:xfrm>
              <a:off x="4763382" y="512068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R-ISS 2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2DC2279D-46D5-38EB-4411-91A47D5DF16D}"/>
                </a:ext>
              </a:extLst>
            </p:cNvPr>
            <p:cNvCxnSpPr/>
            <p:nvPr/>
          </p:nvCxnSpPr>
          <p:spPr>
            <a:xfrm>
              <a:off x="5321603" y="620385"/>
              <a:ext cx="293614" cy="0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1BB5D44-E651-4F0C-3CB5-FA40175DDD2C}"/>
                </a:ext>
              </a:extLst>
            </p:cNvPr>
            <p:cNvSpPr txBox="1"/>
            <p:nvPr/>
          </p:nvSpPr>
          <p:spPr>
            <a:xfrm>
              <a:off x="5595291" y="513466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R-ISS 3</a:t>
              </a:r>
              <a:endParaRPr kumimoji="1" lang="ja-JP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973514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20D1683-C325-E627-55D2-C53548636572}"/>
              </a:ext>
            </a:extLst>
          </p:cNvPr>
          <p:cNvSpPr txBox="1"/>
          <p:nvPr/>
        </p:nvSpPr>
        <p:spPr>
          <a:xfrm>
            <a:off x="388066" y="778748"/>
            <a:ext cx="285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2e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D4E5AA3-706F-B449-9A5C-3F6976CB55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066" y="1557766"/>
            <a:ext cx="5496139" cy="415215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F56C567-5D1D-DBE1-10AC-57BEC89244A0}"/>
              </a:ext>
            </a:extLst>
          </p:cNvPr>
          <p:cNvSpPr txBox="1"/>
          <p:nvPr/>
        </p:nvSpPr>
        <p:spPr>
          <a:xfrm>
            <a:off x="6307797" y="778748"/>
            <a:ext cx="2805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Supplementary Figure 2f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F025D3ED-1DD1-E7E2-727C-9E7BD4A668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7797" y="1557766"/>
            <a:ext cx="5499687" cy="4152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69824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8</Words>
  <Application>Microsoft Office PowerPoint</Application>
  <PresentationFormat>ワイド画面</PresentationFormat>
  <Paragraphs>2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游ゴシック</vt:lpstr>
      <vt:lpstr>游ゴシック Light</vt:lpstr>
      <vt:lpstr>Arial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浩彦 柴山</dc:creator>
  <cp:lastModifiedBy>浩彦 柴山</cp:lastModifiedBy>
  <cp:revision>1</cp:revision>
  <dcterms:created xsi:type="dcterms:W3CDTF">2024-01-16T09:27:16Z</dcterms:created>
  <dcterms:modified xsi:type="dcterms:W3CDTF">2024-01-16T09:28:43Z</dcterms:modified>
</cp:coreProperties>
</file>